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6" autoAdjust="0"/>
    <p:restoredTop sz="94660"/>
  </p:normalViewPr>
  <p:slideViewPr>
    <p:cSldViewPr snapToGrid="0">
      <p:cViewPr varScale="1">
        <p:scale>
          <a:sx n="124" d="100"/>
          <a:sy n="124" d="100"/>
        </p:scale>
        <p:origin x="115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68F78-3187-6189-A3FF-8340F790B5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BB0914A-0DA5-BA7C-5537-3A1964657A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AE0FC6-BBCB-74DB-3ED5-05F927E8B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9AE677-2787-B3AF-7CBC-DAEC226EC9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38EB9-5BA6-F2CF-5D5C-268C06F69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617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831A91-5B37-C5CE-2FDC-9BFCC592F4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FF1703-1A51-5DC7-6CEA-8764D2AC57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54B2C-ECC1-4DB2-E2EE-7917FB266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3B1827-761D-DF4C-4D0B-46E2366931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DB1BF6-C99E-2EC2-23B9-C7738610C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296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3C7C6D-8264-2C91-010D-65A9C8699D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BFF8B4-8078-43C1-A713-CC0207C075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99343E-471A-A964-988F-B4DD468C0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ACAA21-165B-3304-22BC-A864741B2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4D4CEA-44AA-E672-62B9-8759213A9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894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5D8C80-F936-3EFB-AF05-BCE9633A36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2B7D1D-28BF-0CDB-3529-9B9D1A2218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4A82ED-CD06-44EC-AF96-4A66ED0369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8F6323-2B27-FB79-E845-960BE3634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FA2565-5D88-62DF-C1B2-664241033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620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C8502-5EEB-1994-2C93-19D0650BE7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A427E5-0486-77E1-6960-EC67CD4363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7BD31D-3841-A653-B86F-CBC7B7064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0C950A-DB85-8198-B79D-F857E448E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697FD0-1A9D-FE00-69E6-4C056C318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961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480885-E3D8-34D1-23D6-6E38D95D7B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A8227F-E546-DD85-9E8B-C5482DA312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DDC1667-17EC-E2EF-FAE7-2F7CF40B95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5CF6DB-03FD-6C26-FAE6-501EE5582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A51D03-10A8-6DAD-43D8-A8FEC499C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A87B59-94AE-03D3-6742-ADDC2FC21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697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0EC1AF-63D0-E113-84D6-97DCA08C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68256F-8F90-805F-ABB1-795D4FF250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C732AB-54AE-AF45-797B-DB3C7A400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BA43649-271F-D497-B701-C0055967B5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9AC0E2-ED3F-753D-6B8D-9C9ECC5DDF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76576D-F955-A20D-5510-CFAF4F312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FD834A2-35C6-8A54-3619-358557888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D7E90A-D3D1-0DFE-2D17-EB829A2E0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207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5034D9-ED01-0EDE-EF37-9F72BDACC7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05927A-3A77-E7BF-EC41-BCDA9CCD3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A345EE-EC91-1B1F-EAED-550532E15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F670BAC-C130-CDA2-431E-C1B0E9A8B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679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52FBD3A-AF1D-4E0A-2566-5D750EFEF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73EC2F-C01D-4CE1-1BEA-815260A57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78EE3A-A5FD-0DB5-ED55-252A70483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7449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CAD814-F6BB-54F4-E4A1-023166DC39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DE7336-CD99-720D-263C-6E975A9F23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C01A56-9C53-4F14-7963-436B933360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EA9688-DFFA-DE1A-611C-8E93CC4B8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07B581-CA0A-014F-203A-A24FB5423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932E52-407A-45F8-FD02-F48529982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21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BBE640-A2F2-FBC7-B34C-D1D01B4A0F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5EC01E-4711-4892-23F3-B4C4436F32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D2820F-DB52-E90B-DB9C-E85426CDA7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6959C4-8417-F4BC-DD48-AC3389168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C538F2-B421-D621-A1B1-D41B4C562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6C6C66-EE77-186F-780F-D97F6D32EC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47128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0BB1F5-3ADC-B7E9-6CE1-1123D00C72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46DB71-16D1-7791-9E7D-641098D2C2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5DA931-77A5-DBEE-AB9E-AED4AB13237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8278D-E5BA-4677-8EFB-38945244D64F}" type="datetimeFigureOut">
              <a:rPr lang="en-US" smtClean="0"/>
              <a:t>3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E35352-F751-9107-5423-20BBDAD7AD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1623A-AABB-17A8-9452-A71C32AE10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67EF69-943F-4156-A347-CCEF858CAF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218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cid:20AB2418-2A4B-4453-AA56-1614736E8519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white surface&#10;&#10;Description automatically generated">
            <a:extLst>
              <a:ext uri="{FF2B5EF4-FFF2-40B4-BE49-F238E27FC236}">
                <a16:creationId xmlns:a16="http://schemas.microsoft.com/office/drawing/2014/main" id="{4DBC625B-4832-E9EF-AE81-D8F9B6AE2474}"/>
              </a:ext>
            </a:extLst>
          </p:cNvPr>
          <p:cNvPicPr>
            <a:picLocks noChangeAspect="1"/>
          </p:cNvPicPr>
          <p:nvPr/>
        </p:nvPicPr>
        <p:blipFill>
          <a:blip r:embed="rId2" r:link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4224" y="507667"/>
            <a:ext cx="4173539" cy="6073292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9EF4AD71-C61C-46A6-ACFE-374B226DAC4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7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097" t="13283" r="34652" b="52095"/>
          <a:stretch/>
        </p:blipFill>
        <p:spPr>
          <a:xfrm>
            <a:off x="5539119" y="1816725"/>
            <a:ext cx="5868657" cy="177831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DF7ABE3-CAD9-5102-1A77-0AD15DD5FC5C}"/>
              </a:ext>
            </a:extLst>
          </p:cNvPr>
          <p:cNvSpPr txBox="1"/>
          <p:nvPr/>
        </p:nvSpPr>
        <p:spPr>
          <a:xfrm>
            <a:off x="5513249" y="939539"/>
            <a:ext cx="6093618" cy="8074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2000" b="1" u="sng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&amp;E staining</a:t>
            </a:r>
            <a:r>
              <a:rPr lang="en-US" sz="2000" b="1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:</a:t>
            </a:r>
            <a:endParaRPr lang="en-US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          WT Control			G3Stg/</a:t>
            </a:r>
            <a:r>
              <a:rPr lang="en-US" sz="1800" b="1" i="1" dirty="0" err="1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Gla</a:t>
            </a:r>
            <a:r>
              <a:rPr lang="en-US" sz="1800" b="1" dirty="0" err="1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KO</a:t>
            </a:r>
            <a:endParaRPr lang="en-US" sz="2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4FE04C7-0ED5-EB1F-6EE6-280D519F03B0}"/>
              </a:ext>
            </a:extLst>
          </p:cNvPr>
          <p:cNvSpPr txBox="1"/>
          <p:nvPr/>
        </p:nvSpPr>
        <p:spPr>
          <a:xfrm>
            <a:off x="0" y="132115"/>
            <a:ext cx="6093618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2860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u="sng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HC Staining</a:t>
            </a:r>
            <a:r>
              <a:rPr lang="en-US" sz="1800" b="1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: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DC0890E-4C21-CB41-BDFC-23438D44EC4C}"/>
              </a:ext>
            </a:extLst>
          </p:cNvPr>
          <p:cNvSpPr txBox="1"/>
          <p:nvPr/>
        </p:nvSpPr>
        <p:spPr>
          <a:xfrm>
            <a:off x="5539119" y="3810133"/>
            <a:ext cx="6094970" cy="10041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0" lvl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dirty="0" err="1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hipeng</a:t>
            </a:r>
            <a:r>
              <a:rPr lang="en-US" sz="1400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Yuan, Wanida </a:t>
            </a:r>
            <a:r>
              <a:rPr lang="en-US" sz="1400" dirty="0" err="1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uangsiriluk</a:t>
            </a:r>
            <a:r>
              <a:rPr lang="en-US" sz="1400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Eric Park, </a:t>
            </a:r>
            <a:r>
              <a:rPr lang="en-US" sz="1400" dirty="0" err="1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Mugdha</a:t>
            </a:r>
            <a:r>
              <a:rPr lang="en-US" sz="1400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eshpande, </a:t>
            </a:r>
            <a:r>
              <a:rPr lang="en-US" sz="1400" dirty="0" err="1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izwana</a:t>
            </a:r>
            <a:r>
              <a:rPr lang="en-US" sz="1400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Islam, Natalia Boukharov. Manuscript ID HUM-2023-222 "Developing gene therapy for mitigating multisystemic pathology in Fabry disease: proof of concept in an aggravated mouse model" Human Gene Therapy, </a:t>
            </a:r>
            <a:r>
              <a:rPr lang="en-US" sz="1400" i="1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 Revision</a:t>
            </a:r>
            <a:r>
              <a:rPr lang="en-US" sz="1400" dirty="0">
                <a:solidFill>
                  <a:srgbClr val="1D2228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6792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6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ayoun Derakhchan</dc:creator>
  <cp:lastModifiedBy>Katayoun Derakhchan</cp:lastModifiedBy>
  <cp:revision>1</cp:revision>
  <dcterms:created xsi:type="dcterms:W3CDTF">2024-03-21T13:19:08Z</dcterms:created>
  <dcterms:modified xsi:type="dcterms:W3CDTF">2024-03-21T13:23:07Z</dcterms:modified>
</cp:coreProperties>
</file>